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0647C58-5711-4792-9656-42DCF6D1132F}" v="1" dt="2023-06-13T15:08:24.1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1" d="100"/>
          <a:sy n="51" d="100"/>
        </p:scale>
        <p:origin x="730" y="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ynard, Maria" userId="c77c737c-4e40-4756-8b61-1452c4e50087" providerId="ADAL" clId="{30647C58-5711-4792-9656-42DCF6D1132F}"/>
    <pc:docChg chg="modSld">
      <pc:chgData name="Maynard, Maria" userId="c77c737c-4e40-4756-8b61-1452c4e50087" providerId="ADAL" clId="{30647C58-5711-4792-9656-42DCF6D1132F}" dt="2023-06-13T15:14:47.474" v="42" actId="6549"/>
      <pc:docMkLst>
        <pc:docMk/>
      </pc:docMkLst>
      <pc:sldChg chg="addSp modSp mod">
        <pc:chgData name="Maynard, Maria" userId="c77c737c-4e40-4756-8b61-1452c4e50087" providerId="ADAL" clId="{30647C58-5711-4792-9656-42DCF6D1132F}" dt="2023-06-13T15:14:47.474" v="42" actId="6549"/>
        <pc:sldMkLst>
          <pc:docMk/>
          <pc:sldMk cId="1164312780" sldId="256"/>
        </pc:sldMkLst>
        <pc:spChg chg="add mod">
          <ac:chgData name="Maynard, Maria" userId="c77c737c-4e40-4756-8b61-1452c4e50087" providerId="ADAL" clId="{30647C58-5711-4792-9656-42DCF6D1132F}" dt="2023-06-13T15:14:47.474" v="42" actId="6549"/>
          <ac:spMkLst>
            <pc:docMk/>
            <pc:sldMk cId="1164312780" sldId="256"/>
            <ac:spMk id="11" creationId="{5EEE3F9C-412D-4982-9137-D831A00913D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03070E-69CA-410D-BD54-0111B5F326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B5E160-15D7-456C-B83A-E5E48F8376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33FD8-4F26-4C6D-8F3B-C394E8337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A9AB0C-FFC3-4DC5-A4CD-45064154C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9E63BB-F358-4ADD-AFDD-C2601912E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884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357877-53D6-48DA-B085-19FAA2D5C2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14DD23-E7D6-4F4D-BA4A-E30616CF8D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8D687-1D07-4552-8C2E-28AC06E7A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4F430-C369-45DD-9EE7-0982AA2B6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4A0A3-04CF-4C76-8D54-0E02EF13A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9885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39D13B-E893-4644-8BBD-4AAAEDCD26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4FBA52-7237-4688-AABB-A87C458DAF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0316F1-C65C-47FB-98D3-4AA5AF862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6E8580-460E-44DD-BE56-EF2313028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6A2162-189D-4A00-A889-41E6109D3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669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542B9-A8D5-453D-B459-950C40B6FD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43F49E-AB02-401E-9D60-E414B5B2C1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924BBB-E481-428E-8B01-9DABCCEDD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10B631-1B4F-4F63-A06E-83E37DD24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9A1805-87FB-41B5-A11F-CC49CD955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181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357A5-C9C1-4438-ABA9-00B9449CF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DA4EA8-DA9D-4A9C-BEA6-80DA46C70E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48C216-4AF2-4555-A653-E91684718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DCA9A4-0970-4C87-B344-3FA8E9E9A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A5D809-2F3D-4EBD-9884-ADB8E500C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6021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F3573-B06B-4C63-BC00-F8D480D070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8BF142-A605-4879-BAD3-BAFFFFE421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615120-A2F8-4475-8112-6C64B781DA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F3E29B-0D44-4A0F-B9EE-6B0C2922A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9918D-9116-4AB6-A4AD-B1D1E6CE2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6F884F-4D1C-45C5-92CC-D2A15287F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542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8220A-1A03-4A55-82E8-9E2FA6A1E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8BD902-AC99-4616-B4A2-148F9FBB88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F9D8E5-FE64-4E5E-9E82-1DBB388495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74E264-DAFD-492A-AFE9-60AF56B133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193D18-B3ED-489F-B685-7D44B57AF2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1353E8-F400-4E1F-8E75-689234276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0AFB1D-3797-4419-A46C-CE8BF7A65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7A7382-1331-4EE4-90B0-E194C03BF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7274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691ED-CD53-476E-A5EA-B3016C4712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AB82B0-48C1-4E3B-BC84-9FB14245C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C02DC3-B95A-45CD-8844-D2388B004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F92CE4-312B-4178-BCAF-EEDF36719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5675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F9D321-BC8F-4BEC-86D1-18E30DD15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A06BF3-D569-46AC-9DC3-CA3775809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DCAC05-AFF7-4F37-A8C6-8B0A0476C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3400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765D5-6550-4B5B-B08B-CE3A35134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9B4968-0F4B-4BFF-9CA8-3E7C0AEC99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D449B0-03CC-4D52-902B-D1A7FBB0C5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BD08DB-BF26-4C76-BF62-ECC248635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227E85-AE12-4284-9A4B-7F4479FB0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2CE58A-6DED-4F0A-B724-0FE4F219A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512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DC7018-6ADD-4EB2-9DEA-BA79F956B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1488AD-3825-40E5-AD02-71B49142F4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079F04-AF64-446B-8F17-FF050E8A11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51C4FE-7770-44B0-B5C2-95E392E2E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FDCAE9-7E2A-421A-8AA6-78A58BD66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E04AF1-B5E5-47C9-94A1-F64CAEC61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5611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8310127-F902-4F5C-964F-140606A61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1263E3-FC20-4E0A-8A7F-6B71F227DF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8C9844-53DF-4D2F-8E3A-C67ECED9CC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2FF5F-E811-4635-B5D4-2C2C83500E03}" type="datetimeFigureOut">
              <a:rPr lang="en-GB" smtClean="0"/>
              <a:t>13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C67B00-22FD-4663-8732-F19BD0A04E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4A38DD-EB8F-42FF-ACDB-ADD0E056A3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5FF3A-DBEB-4DF3-A249-27FFEC1CB1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515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2A8629D4-E26B-4FDF-9769-6815B557E80F}"/>
              </a:ext>
            </a:extLst>
          </p:cNvPr>
          <p:cNvGrpSpPr/>
          <p:nvPr/>
        </p:nvGrpSpPr>
        <p:grpSpPr>
          <a:xfrm>
            <a:off x="9106851" y="3378162"/>
            <a:ext cx="3012351" cy="3539430"/>
            <a:chOff x="8535144" y="3663754"/>
            <a:chExt cx="3122820" cy="3632038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3398EAD3-0BD3-4D62-AB64-DB5647A64110}"/>
                </a:ext>
              </a:extLst>
            </p:cNvPr>
            <p:cNvGrpSpPr/>
            <p:nvPr/>
          </p:nvGrpSpPr>
          <p:grpSpPr>
            <a:xfrm>
              <a:off x="8535144" y="3663754"/>
              <a:ext cx="3122820" cy="3632038"/>
              <a:chOff x="9293065" y="3659233"/>
              <a:chExt cx="3472647" cy="4021231"/>
            </a:xfrm>
          </p:grpSpPr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A52ABE0B-254C-48E2-A9AC-F0EE38BBC302}"/>
                  </a:ext>
                </a:extLst>
              </p:cNvPr>
              <p:cNvSpPr/>
              <p:nvPr/>
            </p:nvSpPr>
            <p:spPr>
              <a:xfrm>
                <a:off x="9796391" y="5382577"/>
                <a:ext cx="520506" cy="495171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GB" dirty="0"/>
                  <a:t>0</a:t>
                </a:r>
              </a:p>
            </p:txBody>
          </p:sp>
          <p:sp>
            <p:nvSpPr>
              <p:cNvPr id="18" name="Diamond 17">
                <a:extLst>
                  <a:ext uri="{FF2B5EF4-FFF2-40B4-BE49-F238E27FC236}">
                    <a16:creationId xmlns:a16="http://schemas.microsoft.com/office/drawing/2014/main" id="{39E67F2B-47F8-4E3D-9887-19ECA50224A1}"/>
                  </a:ext>
                </a:extLst>
              </p:cNvPr>
              <p:cNvSpPr/>
              <p:nvPr/>
            </p:nvSpPr>
            <p:spPr>
              <a:xfrm>
                <a:off x="9802837" y="4692076"/>
                <a:ext cx="520507" cy="584331"/>
              </a:xfrm>
              <a:prstGeom prst="diamond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/>
              </a:p>
            </p:txBody>
          </p:sp>
          <p:sp>
            <p:nvSpPr>
              <p:cNvPr id="26" name="Rectangle: Rounded Corners 25">
                <a:extLst>
                  <a:ext uri="{FF2B5EF4-FFF2-40B4-BE49-F238E27FC236}">
                    <a16:creationId xmlns:a16="http://schemas.microsoft.com/office/drawing/2014/main" id="{A4A84717-12F3-439C-89CC-B1853D61A57D}"/>
                  </a:ext>
                </a:extLst>
              </p:cNvPr>
              <p:cNvSpPr/>
              <p:nvPr/>
            </p:nvSpPr>
            <p:spPr>
              <a:xfrm>
                <a:off x="9489515" y="4119379"/>
                <a:ext cx="1033677" cy="469000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GB" sz="105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0FAE10E2-6B2C-4F44-9A7B-0E829579BF68}"/>
                  </a:ext>
                </a:extLst>
              </p:cNvPr>
              <p:cNvSpPr txBox="1"/>
              <p:nvPr/>
            </p:nvSpPr>
            <p:spPr>
              <a:xfrm>
                <a:off x="9293065" y="6987572"/>
                <a:ext cx="1224985" cy="474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/>
                  <a:t>-------------</a:t>
                </a:r>
              </a:p>
            </p:txBody>
          </p:sp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1D524336-8485-4F20-A121-84EEDCCD3AC3}"/>
                  </a:ext>
                </a:extLst>
              </p:cNvPr>
              <p:cNvSpPr txBox="1"/>
              <p:nvPr/>
            </p:nvSpPr>
            <p:spPr>
              <a:xfrm>
                <a:off x="9430953" y="3659233"/>
                <a:ext cx="3334759" cy="40212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ey:</a:t>
                </a:r>
              </a:p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</a:t>
                </a:r>
              </a:p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Overarching theme</a:t>
                </a:r>
              </a:p>
              <a:p>
                <a:endPara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</a:t>
                </a:r>
              </a:p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Participant subtheme</a:t>
                </a:r>
              </a:p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</a:t>
                </a:r>
              </a:p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Service provider 	subtheme</a:t>
                </a:r>
              </a:p>
              <a:p>
                <a:endPara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Participant &amp; 	practitioner </a:t>
                </a:r>
              </a:p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subtheme</a:t>
                </a:r>
              </a:p>
              <a:p>
                <a:r>
                  <a:rPr lang="en-GB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</a:t>
                </a:r>
              </a:p>
              <a:p>
                <a:r>
                  <a:rPr lang="en-GB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Links between 	themes</a:t>
                </a:r>
                <a:endParaRPr lang="en-GB" sz="1400" b="1" dirty="0"/>
              </a:p>
            </p:txBody>
          </p:sp>
        </p:grpSp>
        <p:sp>
          <p:nvSpPr>
            <p:cNvPr id="31" name="Diamond 30">
              <a:extLst>
                <a:ext uri="{FF2B5EF4-FFF2-40B4-BE49-F238E27FC236}">
                  <a16:creationId xmlns:a16="http://schemas.microsoft.com/office/drawing/2014/main" id="{59CBC64D-5970-46FD-8630-C661348892E2}"/>
                </a:ext>
              </a:extLst>
            </p:cNvPr>
            <p:cNvSpPr/>
            <p:nvPr/>
          </p:nvSpPr>
          <p:spPr>
            <a:xfrm>
              <a:off x="8987077" y="5763445"/>
              <a:ext cx="468073" cy="527777"/>
            </a:xfrm>
            <a:prstGeom prst="diamond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GB"/>
            </a:p>
          </p:txBody>
        </p:sp>
      </p:grp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6165B87C-8A97-432C-AB78-DDE281294A74}"/>
              </a:ext>
            </a:extLst>
          </p:cNvPr>
          <p:cNvCxnSpPr>
            <a:cxnSpLocks/>
          </p:cNvCxnSpPr>
          <p:nvPr/>
        </p:nvCxnSpPr>
        <p:spPr>
          <a:xfrm flipH="1">
            <a:off x="9246822" y="4531146"/>
            <a:ext cx="29596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3306A1D7-06E6-428E-A1AE-73F9279A2ED6}"/>
              </a:ext>
            </a:extLst>
          </p:cNvPr>
          <p:cNvCxnSpPr>
            <a:cxnSpLocks/>
          </p:cNvCxnSpPr>
          <p:nvPr/>
        </p:nvCxnSpPr>
        <p:spPr>
          <a:xfrm flipH="1">
            <a:off x="9225131" y="5678728"/>
            <a:ext cx="29596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599B3EA2-2AA2-485E-B484-603B9DADA990}"/>
              </a:ext>
            </a:extLst>
          </p:cNvPr>
          <p:cNvCxnSpPr>
            <a:cxnSpLocks/>
          </p:cNvCxnSpPr>
          <p:nvPr/>
        </p:nvCxnSpPr>
        <p:spPr>
          <a:xfrm flipH="1">
            <a:off x="9231805" y="5091525"/>
            <a:ext cx="29596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0" name="Group 39">
            <a:extLst>
              <a:ext uri="{FF2B5EF4-FFF2-40B4-BE49-F238E27FC236}">
                <a16:creationId xmlns:a16="http://schemas.microsoft.com/office/drawing/2014/main" id="{F6B445F2-E3F0-429D-A260-1373168B9BF7}"/>
              </a:ext>
            </a:extLst>
          </p:cNvPr>
          <p:cNvGrpSpPr/>
          <p:nvPr/>
        </p:nvGrpSpPr>
        <p:grpSpPr>
          <a:xfrm>
            <a:off x="16045" y="912742"/>
            <a:ext cx="10187603" cy="5805668"/>
            <a:chOff x="53753" y="912668"/>
            <a:chExt cx="10428631" cy="5822377"/>
          </a:xfrm>
        </p:grpSpPr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C11830FF-3B88-4C43-913E-55B8F0D7EC02}"/>
                </a:ext>
              </a:extLst>
            </p:cNvPr>
            <p:cNvCxnSpPr>
              <a:cxnSpLocks/>
              <a:stCxn id="4" idx="2"/>
              <a:endCxn id="56" idx="0"/>
            </p:cNvCxnSpPr>
            <p:nvPr/>
          </p:nvCxnSpPr>
          <p:spPr>
            <a:xfrm flipH="1">
              <a:off x="2242210" y="1926231"/>
              <a:ext cx="182793" cy="3303106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9930D390-768D-4019-91F5-73BD009FC1FF}"/>
                </a:ext>
              </a:extLst>
            </p:cNvPr>
            <p:cNvGrpSpPr/>
            <p:nvPr/>
          </p:nvGrpSpPr>
          <p:grpSpPr>
            <a:xfrm>
              <a:off x="53753" y="912668"/>
              <a:ext cx="10428631" cy="5822377"/>
              <a:chOff x="53753" y="912668"/>
              <a:chExt cx="10428631" cy="5822377"/>
            </a:xfrm>
          </p:grpSpPr>
          <p:grpSp>
            <p:nvGrpSpPr>
              <p:cNvPr id="128" name="Group 127">
                <a:extLst>
                  <a:ext uri="{FF2B5EF4-FFF2-40B4-BE49-F238E27FC236}">
                    <a16:creationId xmlns:a16="http://schemas.microsoft.com/office/drawing/2014/main" id="{025C0723-5692-4837-818A-BE30D334891A}"/>
                  </a:ext>
                </a:extLst>
              </p:cNvPr>
              <p:cNvGrpSpPr/>
              <p:nvPr/>
            </p:nvGrpSpPr>
            <p:grpSpPr>
              <a:xfrm>
                <a:off x="53753" y="912668"/>
                <a:ext cx="10428631" cy="5822377"/>
                <a:chOff x="53753" y="912668"/>
                <a:chExt cx="10428631" cy="5822377"/>
              </a:xfrm>
            </p:grpSpPr>
            <p:cxnSp>
              <p:nvCxnSpPr>
                <p:cNvPr id="84" name="Straight Connector 83">
                  <a:extLst>
                    <a:ext uri="{FF2B5EF4-FFF2-40B4-BE49-F238E27FC236}">
                      <a16:creationId xmlns:a16="http://schemas.microsoft.com/office/drawing/2014/main" id="{DBE3FC2C-7670-4BEF-AC0B-F2241F74A415}"/>
                    </a:ext>
                  </a:extLst>
                </p:cNvPr>
                <p:cNvCxnSpPr>
                  <a:cxnSpLocks/>
                  <a:stCxn id="8" idx="2"/>
                  <a:endCxn id="64" idx="0"/>
                </p:cNvCxnSpPr>
                <p:nvPr/>
              </p:nvCxnSpPr>
              <p:spPr>
                <a:xfrm>
                  <a:off x="5809413" y="4615782"/>
                  <a:ext cx="1464948" cy="756193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127" name="Group 126">
                  <a:extLst>
                    <a:ext uri="{FF2B5EF4-FFF2-40B4-BE49-F238E27FC236}">
                      <a16:creationId xmlns:a16="http://schemas.microsoft.com/office/drawing/2014/main" id="{4081B354-0222-418D-953E-88D6895B2495}"/>
                    </a:ext>
                  </a:extLst>
                </p:cNvPr>
                <p:cNvGrpSpPr/>
                <p:nvPr/>
              </p:nvGrpSpPr>
              <p:grpSpPr>
                <a:xfrm>
                  <a:off x="53753" y="912668"/>
                  <a:ext cx="10428631" cy="5822377"/>
                  <a:chOff x="53753" y="912668"/>
                  <a:chExt cx="10428631" cy="5822377"/>
                </a:xfrm>
              </p:grpSpPr>
              <p:cxnSp>
                <p:nvCxnSpPr>
                  <p:cNvPr id="43" name="Straight Connector 42">
                    <a:extLst>
                      <a:ext uri="{FF2B5EF4-FFF2-40B4-BE49-F238E27FC236}">
                        <a16:creationId xmlns:a16="http://schemas.microsoft.com/office/drawing/2014/main" id="{160D60DB-815A-44C7-B646-F64F882A943C}"/>
                      </a:ext>
                    </a:extLst>
                  </p:cNvPr>
                  <p:cNvCxnSpPr>
                    <a:cxnSpLocks/>
                    <a:stCxn id="6" idx="1"/>
                    <a:endCxn id="12" idx="0"/>
                  </p:cNvCxnSpPr>
                  <p:nvPr/>
                </p:nvCxnSpPr>
                <p:spPr>
                  <a:xfrm flipH="1">
                    <a:off x="821908" y="4103570"/>
                    <a:ext cx="854492" cy="263585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26" name="Group 125">
                    <a:extLst>
                      <a:ext uri="{FF2B5EF4-FFF2-40B4-BE49-F238E27FC236}">
                        <a16:creationId xmlns:a16="http://schemas.microsoft.com/office/drawing/2014/main" id="{38882136-C877-4C98-BDEC-EDBD727D279C}"/>
                      </a:ext>
                    </a:extLst>
                  </p:cNvPr>
                  <p:cNvGrpSpPr/>
                  <p:nvPr/>
                </p:nvGrpSpPr>
                <p:grpSpPr>
                  <a:xfrm>
                    <a:off x="53753" y="912668"/>
                    <a:ext cx="10428631" cy="5822377"/>
                    <a:chOff x="53753" y="912668"/>
                    <a:chExt cx="10428631" cy="5822377"/>
                  </a:xfrm>
                </p:grpSpPr>
                <p:grpSp>
                  <p:nvGrpSpPr>
                    <p:cNvPr id="125" name="Group 124">
                      <a:extLst>
                        <a:ext uri="{FF2B5EF4-FFF2-40B4-BE49-F238E27FC236}">
                          <a16:creationId xmlns:a16="http://schemas.microsoft.com/office/drawing/2014/main" id="{B482E614-81CF-4A83-AA6A-2AA01320306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753" y="912668"/>
                      <a:ext cx="10428631" cy="5822377"/>
                      <a:chOff x="53753" y="912668"/>
                      <a:chExt cx="10428631" cy="5822377"/>
                    </a:xfrm>
                  </p:grpSpPr>
                  <p:cxnSp>
                    <p:nvCxnSpPr>
                      <p:cNvPr id="72" name="Straight Connector 71">
                        <a:extLst>
                          <a:ext uri="{FF2B5EF4-FFF2-40B4-BE49-F238E27FC236}">
                            <a16:creationId xmlns:a16="http://schemas.microsoft.com/office/drawing/2014/main" id="{CA20231D-D1CC-49B4-83BC-3F07A158A2C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840048" y="4506494"/>
                        <a:ext cx="604056" cy="508588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9" name="Straight Connector 88">
                        <a:extLst>
                          <a:ext uri="{FF2B5EF4-FFF2-40B4-BE49-F238E27FC236}">
                            <a16:creationId xmlns:a16="http://schemas.microsoft.com/office/drawing/2014/main" id="{0631488F-0CCD-4E6A-821D-EB88E3882065}"/>
                          </a:ext>
                        </a:extLst>
                      </p:cNvPr>
                      <p:cNvCxnSpPr>
                        <a:cxnSpLocks/>
                        <a:stCxn id="7" idx="2"/>
                      </p:cNvCxnSpPr>
                      <p:nvPr/>
                    </p:nvCxnSpPr>
                    <p:spPr>
                      <a:xfrm>
                        <a:off x="4819630" y="1926232"/>
                        <a:ext cx="2891615" cy="1439535"/>
                      </a:xfrm>
                      <a:prstGeom prst="line">
                        <a:avLst/>
                      </a:prstGeom>
                      <a:ln>
                        <a:prstDash val="dash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4" name="Straight Connector 73">
                        <a:extLst>
                          <a:ext uri="{FF2B5EF4-FFF2-40B4-BE49-F238E27FC236}">
                            <a16:creationId xmlns:a16="http://schemas.microsoft.com/office/drawing/2014/main" id="{9FFC4F40-2CD1-4157-A6D9-4B594D77328C}"/>
                          </a:ext>
                        </a:extLst>
                      </p:cNvPr>
                      <p:cNvCxnSpPr>
                        <a:cxnSpLocks/>
                        <a:stCxn id="9" idx="5"/>
                      </p:cNvCxnSpPr>
                      <p:nvPr/>
                    </p:nvCxnSpPr>
                    <p:spPr>
                      <a:xfrm>
                        <a:off x="1482973" y="2576756"/>
                        <a:ext cx="5913507" cy="2360021"/>
                      </a:xfrm>
                      <a:prstGeom prst="line">
                        <a:avLst/>
                      </a:prstGeom>
                      <a:ln>
                        <a:prstDash val="dash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" name="Rectangle: Rounded Corners 3">
                        <a:extLst>
                          <a:ext uri="{FF2B5EF4-FFF2-40B4-BE49-F238E27FC236}">
                            <a16:creationId xmlns:a16="http://schemas.microsoft.com/office/drawing/2014/main" id="{3049BD5F-3DCB-4C7D-86C5-68E0E5FD018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639495" y="937997"/>
                        <a:ext cx="1571015" cy="988234"/>
                      </a:xfrm>
                      <a:prstGeom prst="round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t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1. Positive about life, but in the shadow of racism</a:t>
                        </a:r>
                        <a:endParaRPr lang="en-GB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  <a:p>
                        <a:endParaRPr lang="en-GB" sz="1050" dirty="0">
                          <a:solidFill>
                            <a:schemeClr val="tx1"/>
                          </a:solidFill>
                        </a:endParaRPr>
                      </a:p>
                    </p:txBody>
                  </p:sp>
                  <p:sp>
                    <p:nvSpPr>
                      <p:cNvPr id="5" name="Rectangle: Rounded Corners 4">
                        <a:extLst>
                          <a:ext uri="{FF2B5EF4-FFF2-40B4-BE49-F238E27FC236}">
                            <a16:creationId xmlns:a16="http://schemas.microsoft.com/office/drawing/2014/main" id="{5E3D54CE-FD5A-410A-BF72-DEF7A179347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757065" y="937997"/>
                        <a:ext cx="1732281" cy="1013564"/>
                      </a:xfrm>
                      <a:prstGeom prst="round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t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. Acceptance of larger body size in context of complex weight loss motivation</a:t>
                        </a:r>
                      </a:p>
                    </p:txBody>
                  </p:sp>
                  <p:sp>
                    <p:nvSpPr>
                      <p:cNvPr id="7" name="Rectangle: Rounded Corners 6">
                        <a:extLst>
                          <a:ext uri="{FF2B5EF4-FFF2-40B4-BE49-F238E27FC236}">
                            <a16:creationId xmlns:a16="http://schemas.microsoft.com/office/drawing/2014/main" id="{2512FAAC-27E7-4F4B-9A67-3C3642A2953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972560" y="912668"/>
                        <a:ext cx="1694140" cy="1013564"/>
                      </a:xfrm>
                      <a:prstGeom prst="round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t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effectLst/>
                            <a:latin typeface="Times New Roman" panose="02020603050405020304" pitchFamily="18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2. Weight gain attributed to unhealthy behaviours and the environment</a:t>
                        </a:r>
                        <a:endParaRPr lang="en-GB" sz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  <a:p>
                        <a:endParaRPr lang="en-GB" dirty="0"/>
                      </a:p>
                    </p:txBody>
                  </p:sp>
                  <p:sp>
                    <p:nvSpPr>
                      <p:cNvPr id="8" name="Rectangle: Rounded Corners 7">
                        <a:extLst>
                          <a:ext uri="{FF2B5EF4-FFF2-40B4-BE49-F238E27FC236}">
                            <a16:creationId xmlns:a16="http://schemas.microsoft.com/office/drawing/2014/main" id="{2BEFD77F-4856-4EB1-BA34-78E933AAF89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921890" y="3599815"/>
                        <a:ext cx="1775047" cy="1015968"/>
                      </a:xfrm>
                      <a:prstGeom prst="round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t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5. Ideal weight management support: community based, culturally tailored &amp; flexible</a:t>
                        </a:r>
                      </a:p>
                    </p:txBody>
                  </p:sp>
                  <p:sp>
                    <p:nvSpPr>
                      <p:cNvPr id="9" name="Oval 8">
                        <a:extLst>
                          <a:ext uri="{FF2B5EF4-FFF2-40B4-BE49-F238E27FC236}">
                            <a16:creationId xmlns:a16="http://schemas.microsoft.com/office/drawing/2014/main" id="{D95BCE7F-CAF1-4645-B7A2-9862B6CD2E6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55600" y="1602955"/>
                        <a:ext cx="1320800" cy="1140879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ringing your ‘big self’ to work</a:t>
                        </a:r>
                      </a:p>
                    </p:txBody>
                  </p:sp>
                  <p:sp>
                    <p:nvSpPr>
                      <p:cNvPr id="12" name="Oval 11">
                        <a:extLst>
                          <a:ext uri="{FF2B5EF4-FFF2-40B4-BE49-F238E27FC236}">
                            <a16:creationId xmlns:a16="http://schemas.microsoft.com/office/drawing/2014/main" id="{07BF92E2-AC9E-435B-8EF4-294BEDA8CA3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3753" y="4367156"/>
                        <a:ext cx="1536309" cy="1270390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t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Missed opportunities in GP consultations and referral</a:t>
                        </a:r>
                      </a:p>
                      <a:p>
                        <a:endPara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  <a:p>
                        <a:endPara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  <a:p>
                        <a:endParaRPr lang="en-GB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  <a:p>
                        <a:r>
                          <a:rPr lang="en-GB" sz="11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 </a:t>
                        </a:r>
                      </a:p>
                    </p:txBody>
                  </p:sp>
                  <p:sp>
                    <p:nvSpPr>
                      <p:cNvPr id="14" name="Diamond 13">
                        <a:extLst>
                          <a:ext uri="{FF2B5EF4-FFF2-40B4-BE49-F238E27FC236}">
                            <a16:creationId xmlns:a16="http://schemas.microsoft.com/office/drawing/2014/main" id="{4BA1A63D-2098-47B0-A64D-E36683C2572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68847" y="4584754"/>
                        <a:ext cx="2114427" cy="1190521"/>
                      </a:xfrm>
                      <a:prstGeom prst="diamond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Lack of tailoring and relevant resources</a:t>
                        </a:r>
                      </a:p>
                    </p:txBody>
                  </p:sp>
                  <p:sp>
                    <p:nvSpPr>
                      <p:cNvPr id="21" name="Diamond 20">
                        <a:extLst>
                          <a:ext uri="{FF2B5EF4-FFF2-40B4-BE49-F238E27FC236}">
                            <a16:creationId xmlns:a16="http://schemas.microsoft.com/office/drawing/2014/main" id="{079042AF-4E20-419B-AC2A-E3CEFE16B3C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286860" y="5247923"/>
                        <a:ext cx="1973805" cy="1158841"/>
                      </a:xfrm>
                      <a:prstGeom prst="diamond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ommunity engagement</a:t>
                        </a:r>
                      </a:p>
                    </p:txBody>
                  </p:sp>
                  <p:sp>
                    <p:nvSpPr>
                      <p:cNvPr id="32" name="Diamond 31">
                        <a:extLst>
                          <a:ext uri="{FF2B5EF4-FFF2-40B4-BE49-F238E27FC236}">
                            <a16:creationId xmlns:a16="http://schemas.microsoft.com/office/drawing/2014/main" id="{30024B42-8CC5-4F7B-97C6-F36042170963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346859" y="4309808"/>
                        <a:ext cx="1968745" cy="1183152"/>
                      </a:xfrm>
                      <a:prstGeom prst="diamond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ultural tailoring: programme content</a:t>
                        </a:r>
                      </a:p>
                    </p:txBody>
                  </p:sp>
                  <p:cxnSp>
                    <p:nvCxnSpPr>
                      <p:cNvPr id="36" name="Straight Connector 35">
                        <a:extLst>
                          <a:ext uri="{FF2B5EF4-FFF2-40B4-BE49-F238E27FC236}">
                            <a16:creationId xmlns:a16="http://schemas.microsoft.com/office/drawing/2014/main" id="{CF646375-FCC6-4956-8512-63561AE0A362}"/>
                          </a:ext>
                        </a:extLst>
                      </p:cNvPr>
                      <p:cNvCxnSpPr>
                        <a:cxnSpLocks/>
                        <a:stCxn id="4" idx="1"/>
                        <a:endCxn id="9" idx="0"/>
                      </p:cNvCxnSpPr>
                      <p:nvPr/>
                    </p:nvCxnSpPr>
                    <p:spPr>
                      <a:xfrm flipH="1">
                        <a:off x="1016001" y="1432114"/>
                        <a:ext cx="623494" cy="170841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0" name="Diamond 59">
                        <a:extLst>
                          <a:ext uri="{FF2B5EF4-FFF2-40B4-BE49-F238E27FC236}">
                            <a16:creationId xmlns:a16="http://schemas.microsoft.com/office/drawing/2014/main" id="{10C58B2D-790A-4960-99B6-C890B59599D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8333011" y="1773784"/>
                        <a:ext cx="2149373" cy="1283152"/>
                      </a:xfrm>
                      <a:prstGeom prst="diamond">
                        <a:avLst/>
                      </a:prstGeom>
                      <a:solidFill>
                        <a:schemeClr val="bg1">
                          <a:lumMod val="85000"/>
                        </a:schemeClr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reference for alternatives to BMI measures </a:t>
                        </a:r>
                      </a:p>
                    </p:txBody>
                  </p:sp>
                  <p:sp>
                    <p:nvSpPr>
                      <p:cNvPr id="64" name="Diamond 63">
                        <a:extLst>
                          <a:ext uri="{FF2B5EF4-FFF2-40B4-BE49-F238E27FC236}">
                            <a16:creationId xmlns:a16="http://schemas.microsoft.com/office/drawing/2014/main" id="{6955D600-9A3D-4427-B574-1A278096B14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978545" y="5371975"/>
                        <a:ext cx="2591632" cy="1363070"/>
                      </a:xfrm>
                      <a:prstGeom prst="diamond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1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ultural tailoring: gender and weight-matching  unimportant/ undesirable </a:t>
                        </a:r>
                      </a:p>
                    </p:txBody>
                  </p:sp>
                  <p:cxnSp>
                    <p:nvCxnSpPr>
                      <p:cNvPr id="69" name="Straight Connector 68">
                        <a:extLst>
                          <a:ext uri="{FF2B5EF4-FFF2-40B4-BE49-F238E27FC236}">
                            <a16:creationId xmlns:a16="http://schemas.microsoft.com/office/drawing/2014/main" id="{211EE990-DFC1-4086-803C-0B0E5769434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210512" y="1949828"/>
                        <a:ext cx="943223" cy="1649987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  <a:prstDash val="dash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76" name="Diamond 75">
                        <a:extLst>
                          <a:ext uri="{FF2B5EF4-FFF2-40B4-BE49-F238E27FC236}">
                            <a16:creationId xmlns:a16="http://schemas.microsoft.com/office/drawing/2014/main" id="{D2C90990-6753-4E73-A66E-15F934975D8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158748" y="2895602"/>
                        <a:ext cx="2327544" cy="1327860"/>
                      </a:xfrm>
                      <a:prstGeom prst="diamond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r>
                          <a:rPr lang="en-GB" sz="1200" b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Education, psychosocial support</a:t>
                        </a:r>
                      </a:p>
                    </p:txBody>
                  </p:sp>
                  <p:cxnSp>
                    <p:nvCxnSpPr>
                      <p:cNvPr id="82" name="Straight Connector 81">
                        <a:extLst>
                          <a:ext uri="{FF2B5EF4-FFF2-40B4-BE49-F238E27FC236}">
                            <a16:creationId xmlns:a16="http://schemas.microsoft.com/office/drawing/2014/main" id="{923944BA-5540-4B7F-80B4-D66C92D4AD49}"/>
                          </a:ext>
                        </a:extLst>
                      </p:cNvPr>
                      <p:cNvCxnSpPr>
                        <a:cxnSpLocks/>
                        <a:stCxn id="8" idx="2"/>
                        <a:endCxn id="21" idx="0"/>
                      </p:cNvCxnSpPr>
                      <p:nvPr/>
                    </p:nvCxnSpPr>
                    <p:spPr>
                      <a:xfrm flipH="1">
                        <a:off x="5273762" y="4615782"/>
                        <a:ext cx="535651" cy="632141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9" name="Straight Connector 108">
                        <a:extLst>
                          <a:ext uri="{FF2B5EF4-FFF2-40B4-BE49-F238E27FC236}">
                            <a16:creationId xmlns:a16="http://schemas.microsoft.com/office/drawing/2014/main" id="{D6B8BD5E-E1A2-4D88-9F3E-7974B92524F2}"/>
                          </a:ext>
                        </a:extLst>
                      </p:cNvPr>
                      <p:cNvCxnSpPr>
                        <a:cxnSpLocks/>
                        <a:stCxn id="5" idx="2"/>
                      </p:cNvCxnSpPr>
                      <p:nvPr/>
                    </p:nvCxnSpPr>
                    <p:spPr>
                      <a:xfrm>
                        <a:off x="7623205" y="1951561"/>
                        <a:ext cx="1073755" cy="24801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2" name="Straight Connector 111">
                        <a:extLst>
                          <a:ext uri="{FF2B5EF4-FFF2-40B4-BE49-F238E27FC236}">
                            <a16:creationId xmlns:a16="http://schemas.microsoft.com/office/drawing/2014/main" id="{30E240F2-4BAA-47FE-8DB0-39D22E521BCE}"/>
                          </a:ext>
                        </a:extLst>
                      </p:cNvPr>
                      <p:cNvCxnSpPr>
                        <a:cxnSpLocks/>
                        <a:stCxn id="8" idx="3"/>
                      </p:cNvCxnSpPr>
                      <p:nvPr/>
                    </p:nvCxnSpPr>
                    <p:spPr>
                      <a:xfrm flipV="1">
                        <a:off x="6696937" y="3740149"/>
                        <a:ext cx="805208" cy="36765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5" name="Straight Connector 114">
                        <a:extLst>
                          <a:ext uri="{FF2B5EF4-FFF2-40B4-BE49-F238E27FC236}">
                            <a16:creationId xmlns:a16="http://schemas.microsoft.com/office/drawing/2014/main" id="{598E2105-9740-4F9F-B391-3A86D8E106C7}"/>
                          </a:ext>
                        </a:extLst>
                      </p:cNvPr>
                      <p:cNvCxnSpPr>
                        <a:cxnSpLocks/>
                        <a:stCxn id="8" idx="3"/>
                        <a:endCxn id="32" idx="0"/>
                      </p:cNvCxnSpPr>
                      <p:nvPr/>
                    </p:nvCxnSpPr>
                    <p:spPr>
                      <a:xfrm>
                        <a:off x="6696937" y="4107798"/>
                        <a:ext cx="1634295" cy="20201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6" name="Rectangle: Rounded Corners 5">
                      <a:extLst>
                        <a:ext uri="{FF2B5EF4-FFF2-40B4-BE49-F238E27FC236}">
                          <a16:creationId xmlns:a16="http://schemas.microsoft.com/office/drawing/2014/main" id="{9BE42EEC-B906-4DCF-B8B4-88AD464181A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76400" y="3599814"/>
                      <a:ext cx="1816270" cy="1007513"/>
                    </a:xfrm>
                    <a:prstGeom prst="round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/>
                      <a:r>
                        <a:rPr lang="en-GB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 Self-help preferred to formal weight management programmes to lose weight</a:t>
                      </a:r>
                    </a:p>
                  </p:txBody>
                </p:sp>
              </p:grpSp>
            </p:grpSp>
          </p:grpSp>
          <p:sp>
            <p:nvSpPr>
              <p:cNvPr id="56" name="Diamond 55">
                <a:extLst>
                  <a:ext uri="{FF2B5EF4-FFF2-40B4-BE49-F238E27FC236}">
                    <a16:creationId xmlns:a16="http://schemas.microsoft.com/office/drawing/2014/main" id="{200A0C73-840D-4312-8AED-7A5FD55DDF24}"/>
                  </a:ext>
                </a:extLst>
              </p:cNvPr>
              <p:cNvSpPr/>
              <p:nvPr/>
            </p:nvSpPr>
            <p:spPr>
              <a:xfrm>
                <a:off x="967823" y="5229337"/>
                <a:ext cx="2548774" cy="1137373"/>
              </a:xfrm>
              <a:prstGeom prst="diamond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GB" sz="12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or communication of  weight management services</a:t>
                </a:r>
              </a:p>
            </p:txBody>
          </p:sp>
        </p:grp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5EEE3F9C-412D-4982-9137-D831A00913DF}"/>
              </a:ext>
            </a:extLst>
          </p:cNvPr>
          <p:cNvSpPr txBox="1"/>
          <p:nvPr/>
        </p:nvSpPr>
        <p:spPr>
          <a:xfrm>
            <a:off x="3099842" y="301214"/>
            <a:ext cx="39571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3. Thematic map</a:t>
            </a:r>
          </a:p>
        </p:txBody>
      </p:sp>
    </p:spTree>
    <p:extLst>
      <p:ext uri="{BB962C8B-B14F-4D97-AF65-F5344CB8AC3E}">
        <p14:creationId xmlns:p14="http://schemas.microsoft.com/office/powerpoint/2010/main" val="11643127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</a:spPr>
      <a:bodyPr rot="0" spcFirstLastPara="0" vert="horz" wrap="square" lIns="91440" tIns="45720" rIns="91440" bIns="45720" numCol="1" spcCol="0" rtlCol="0" fromWordArt="0" anchor="t" anchorCtr="0" forceAA="0" compatLnSpc="1">
        <a:prstTxWarp prst="textNoShape">
          <a:avLst/>
        </a:prstTxWarp>
        <a:noAutofit/>
      </a:bodyPr>
      <a:lstStyle>
        <a:defPPr algn="l">
          <a:defRPr sz="1050" b="1" i="1" dirty="0" smtClean="0">
            <a:solidFill>
              <a:schemeClr val="tx1"/>
            </a:solidFill>
            <a:effectLst/>
            <a:latin typeface="Times New Roman" panose="02020603050405020304" pitchFamily="18" charset="0"/>
            <a:ea typeface="Calibri" panose="020F0502020204030204" pitchFamily="34" charset="0"/>
            <a:cs typeface="Times New Roman" panose="02020603050405020304" pitchFamily="18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6</TotalTime>
  <Words>154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ynard, Maria</dc:creator>
  <cp:lastModifiedBy>Maynard, Maria</cp:lastModifiedBy>
  <cp:revision>7</cp:revision>
  <dcterms:created xsi:type="dcterms:W3CDTF">2021-11-06T16:38:02Z</dcterms:created>
  <dcterms:modified xsi:type="dcterms:W3CDTF">2023-06-13T15:14:54Z</dcterms:modified>
</cp:coreProperties>
</file>